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C2F37-FEC4-479A-9824-0B1B1E05D512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E1123-2738-4906-A899-958FE8F80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0282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C2F37-FEC4-479A-9824-0B1B1E05D512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E1123-2738-4906-A899-958FE8F80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0423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C2F37-FEC4-479A-9824-0B1B1E05D512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E1123-2738-4906-A899-958FE8F80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8802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C2F37-FEC4-479A-9824-0B1B1E05D512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E1123-2738-4906-A899-958FE8F80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048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C2F37-FEC4-479A-9824-0B1B1E05D512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E1123-2738-4906-A899-958FE8F80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4899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C2F37-FEC4-479A-9824-0B1B1E05D512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E1123-2738-4906-A899-958FE8F80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121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C2F37-FEC4-479A-9824-0B1B1E05D512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E1123-2738-4906-A899-958FE8F80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6780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C2F37-FEC4-479A-9824-0B1B1E05D512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E1123-2738-4906-A899-958FE8F80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24857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C2F37-FEC4-479A-9824-0B1B1E05D512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E1123-2738-4906-A899-958FE8F80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5930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C2F37-FEC4-479A-9824-0B1B1E05D512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E1123-2738-4906-A899-958FE8F80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6664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C2F37-FEC4-479A-9824-0B1B1E05D512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E1123-2738-4906-A899-958FE8F80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39600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7C2F37-FEC4-479A-9824-0B1B1E05D512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1E1123-2738-4906-A899-958FE8F80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519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/>
          <a:srcRect t="2674" b="28466"/>
          <a:stretch/>
        </p:blipFill>
        <p:spPr>
          <a:xfrm rot="16200000">
            <a:off x="4068192" y="1019657"/>
            <a:ext cx="3598415" cy="3302493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3D6669D3-0575-904E-B42E-6CCA8941F469}"/>
              </a:ext>
            </a:extLst>
          </p:cNvPr>
          <p:cNvSpPr txBox="1"/>
          <p:nvPr/>
        </p:nvSpPr>
        <p:spPr>
          <a:xfrm>
            <a:off x="975360" y="5062974"/>
            <a:ext cx="978408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Fig. 2. The SDS-PAGE result of the purified His6-GlnR protein. The lanes from left to right are marker, solution eluted by lysis buffer containing 20 mM imidazole, solution eluted by 1 mL lysis buffer containing 250 mM imidazole from the first to the fourth time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45501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1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ts</dc:creator>
  <cp:lastModifiedBy>王 天舒</cp:lastModifiedBy>
  <cp:revision>2</cp:revision>
  <dcterms:created xsi:type="dcterms:W3CDTF">2023-01-09T13:23:13Z</dcterms:created>
  <dcterms:modified xsi:type="dcterms:W3CDTF">2023-01-10T07:30:13Z</dcterms:modified>
</cp:coreProperties>
</file>